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2" name="Google Shape;172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20"/>
          <p:cNvSpPr txBox="1"/>
          <p:nvPr/>
        </p:nvSpPr>
        <p:spPr>
          <a:xfrm>
            <a:off x="384538" y="7105988"/>
            <a:ext cx="6088924" cy="19389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1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1.B2 (ATY36097.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; -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B2), TaAmy1.2 (ATY36099.1; α-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2), and TaAmy1.3 (ATY36098.1; 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1). Amino acid differences  between the three TaAmy1 homeologs are shown in bold in both the consensus sequences and in peptide alignments.  Peptides are shown in alternating colors (black/red) and those with the same amino acid sequences are stacked to show the number of times a peptide sequence was recovered from peptide sequencing analysis. In total 30 unique peptides were recovered for the three TaAmy1 homologs. Percent coverages for TaAmy1.1, TaAmy1.2, and TaAmy1.3 were 45.33%, 43.79%, and 45.9%, respectively. 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5" name="Google Shape;175;p2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80060" y="608729"/>
            <a:ext cx="5798820" cy="641691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133</Words>
  <Application>Microsoft Office PowerPoint</Application>
  <PresentationFormat>On-screen Show (4:3)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5:37Z</dcterms:modified>
</cp:coreProperties>
</file>